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1334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694"/>
  </p:normalViewPr>
  <p:slideViewPr>
    <p:cSldViewPr snapToGrid="0" snapToObjects="1">
      <p:cViewPr varScale="1">
        <p:scale>
          <a:sx n="65" d="100"/>
          <a:sy n="65" d="100"/>
        </p:scale>
        <p:origin x="25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9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02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9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781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4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3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98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9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3F83CC03-85E6-E4E8-7B47-91C30310118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822" t="23222" r="23070" b="32795"/>
          <a:stretch/>
        </p:blipFill>
        <p:spPr>
          <a:xfrm>
            <a:off x="834214" y="1087600"/>
            <a:ext cx="2930395" cy="1560006"/>
          </a:xfrm>
          <a:prstGeom prst="rect">
            <a:avLst/>
          </a:prstGeom>
        </p:spPr>
      </p:pic>
      <p:pic>
        <p:nvPicPr>
          <p:cNvPr id="38" name="Picture 37" descr="A picture containing old&#10;&#10;Description automatically generated">
            <a:extLst>
              <a:ext uri="{FF2B5EF4-FFF2-40B4-BE49-F238E27FC236}">
                <a16:creationId xmlns:a16="http://schemas.microsoft.com/office/drawing/2014/main" id="{A8C70A24-4475-77EA-70D5-0E0168AECE9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593" t="31520" r="25673" b="25835"/>
          <a:stretch/>
        </p:blipFill>
        <p:spPr>
          <a:xfrm flipH="1">
            <a:off x="882628" y="4899592"/>
            <a:ext cx="2741580" cy="1468329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083C6367-6FCD-928B-78C3-1CAD7052F18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501" t="50320" r="17677" b="31617"/>
          <a:stretch/>
        </p:blipFill>
        <p:spPr>
          <a:xfrm>
            <a:off x="882628" y="6454610"/>
            <a:ext cx="2741580" cy="67866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396280C-73F3-062F-9161-76774229DC2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8064" t="33459" r="8310" b="41947"/>
          <a:stretch/>
        </p:blipFill>
        <p:spPr>
          <a:xfrm>
            <a:off x="916954" y="2669329"/>
            <a:ext cx="2847655" cy="65756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C2CCCDD0-EC1E-835A-E16E-93B1F67D99DB}"/>
              </a:ext>
            </a:extLst>
          </p:cNvPr>
          <p:cNvSpPr txBox="1"/>
          <p:nvPr/>
        </p:nvSpPr>
        <p:spPr>
          <a:xfrm>
            <a:off x="400723" y="2869481"/>
            <a:ext cx="58862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74D5668-6380-6F97-BC7D-F9D6E3382F1C}"/>
              </a:ext>
            </a:extLst>
          </p:cNvPr>
          <p:cNvSpPr txBox="1"/>
          <p:nvPr/>
        </p:nvSpPr>
        <p:spPr>
          <a:xfrm>
            <a:off x="441432" y="1884599"/>
            <a:ext cx="48603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UPP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F81166B-146E-21B9-6808-B0B34E7553C6}"/>
              </a:ext>
            </a:extLst>
          </p:cNvPr>
          <p:cNvSpPr txBox="1"/>
          <p:nvPr/>
        </p:nvSpPr>
        <p:spPr>
          <a:xfrm>
            <a:off x="398088" y="6695838"/>
            <a:ext cx="58862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F1E211D-6DEC-2B41-68C2-A9CD70A804BD}"/>
              </a:ext>
            </a:extLst>
          </p:cNvPr>
          <p:cNvSpPr txBox="1"/>
          <p:nvPr/>
        </p:nvSpPr>
        <p:spPr>
          <a:xfrm>
            <a:off x="398087" y="5385103"/>
            <a:ext cx="48603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BCFC89E3-94E1-8E26-B51A-4AF9827F62C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86620" y="7219963"/>
            <a:ext cx="1707155" cy="495362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6692005E-25C5-8528-7BA7-799E4D21EA52}"/>
              </a:ext>
            </a:extLst>
          </p:cNvPr>
          <p:cNvSpPr txBox="1"/>
          <p:nvPr/>
        </p:nvSpPr>
        <p:spPr>
          <a:xfrm>
            <a:off x="383426" y="7227284"/>
            <a:ext cx="85953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Trametinib [1uM]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A46A41F-9BBB-E01E-5985-574416765571}"/>
              </a:ext>
            </a:extLst>
          </p:cNvPr>
          <p:cNvSpPr txBox="1"/>
          <p:nvPr/>
        </p:nvSpPr>
        <p:spPr>
          <a:xfrm>
            <a:off x="497239" y="7365967"/>
            <a:ext cx="745717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Uridine [1mM]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40A91AD-2F42-659E-DE38-03C33962EE19}"/>
              </a:ext>
            </a:extLst>
          </p:cNvPr>
          <p:cNvSpPr txBox="1"/>
          <p:nvPr/>
        </p:nvSpPr>
        <p:spPr>
          <a:xfrm>
            <a:off x="452355" y="7504650"/>
            <a:ext cx="79060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Glucose [5mM]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31A47A8-488F-BC25-1008-2BD1A74142F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7988" y="3430159"/>
            <a:ext cx="1707155" cy="49536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97D83688-DD26-4EF3-F04A-976BF4B416D5}"/>
              </a:ext>
            </a:extLst>
          </p:cNvPr>
          <p:cNvSpPr txBox="1"/>
          <p:nvPr/>
        </p:nvSpPr>
        <p:spPr>
          <a:xfrm>
            <a:off x="434793" y="3437479"/>
            <a:ext cx="85953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Trametinib [1uM]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2304D2-5C9D-75D4-AB37-A08F7A416DFC}"/>
              </a:ext>
            </a:extLst>
          </p:cNvPr>
          <p:cNvSpPr txBox="1"/>
          <p:nvPr/>
        </p:nvSpPr>
        <p:spPr>
          <a:xfrm>
            <a:off x="548606" y="3576163"/>
            <a:ext cx="745717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Uridine [1mM]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CFBBD13-57AE-C90D-CE79-0234BDBA6EEB}"/>
              </a:ext>
            </a:extLst>
          </p:cNvPr>
          <p:cNvSpPr txBox="1"/>
          <p:nvPr/>
        </p:nvSpPr>
        <p:spPr>
          <a:xfrm>
            <a:off x="503722" y="3714846"/>
            <a:ext cx="79060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Glucose [5mM]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FC1FE9-10E0-7577-D5AC-8C224154F13E}"/>
              </a:ext>
            </a:extLst>
          </p:cNvPr>
          <p:cNvSpPr txBox="1"/>
          <p:nvPr/>
        </p:nvSpPr>
        <p:spPr>
          <a:xfrm>
            <a:off x="3624207" y="953790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87A894D-1AC8-5693-7555-905FDB0E0153}"/>
              </a:ext>
            </a:extLst>
          </p:cNvPr>
          <p:cNvSpPr txBox="1"/>
          <p:nvPr/>
        </p:nvSpPr>
        <p:spPr>
          <a:xfrm>
            <a:off x="3735927" y="1829483"/>
            <a:ext cx="3129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9E6C6BC-51B6-2C62-CA15-4B64B3409835}"/>
              </a:ext>
            </a:extLst>
          </p:cNvPr>
          <p:cNvSpPr txBox="1"/>
          <p:nvPr/>
        </p:nvSpPr>
        <p:spPr>
          <a:xfrm>
            <a:off x="3664064" y="2871696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98608B5-58A8-4825-FDAA-BB4A677C7331}"/>
              </a:ext>
            </a:extLst>
          </p:cNvPr>
          <p:cNvSpPr txBox="1"/>
          <p:nvPr/>
        </p:nvSpPr>
        <p:spPr>
          <a:xfrm>
            <a:off x="3555289" y="4577021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547D8A4-875A-3500-B400-10FFC75B4985}"/>
              </a:ext>
            </a:extLst>
          </p:cNvPr>
          <p:cNvSpPr txBox="1"/>
          <p:nvPr/>
        </p:nvSpPr>
        <p:spPr>
          <a:xfrm>
            <a:off x="3555290" y="5422265"/>
            <a:ext cx="4732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44/4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ED6F8C2-3626-0771-526D-5BAE005B4CA2}"/>
              </a:ext>
            </a:extLst>
          </p:cNvPr>
          <p:cNvSpPr txBox="1"/>
          <p:nvPr/>
        </p:nvSpPr>
        <p:spPr>
          <a:xfrm>
            <a:off x="3595144" y="6654762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59706D3-8080-EF41-3BED-9C6F86FA3E60}"/>
              </a:ext>
            </a:extLst>
          </p:cNvPr>
          <p:cNvSpPr/>
          <p:nvPr/>
        </p:nvSpPr>
        <p:spPr>
          <a:xfrm>
            <a:off x="1322037" y="1829483"/>
            <a:ext cx="1520725" cy="27137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EE48127-2B5E-6CE7-B479-BD8178A7B981}"/>
              </a:ext>
            </a:extLst>
          </p:cNvPr>
          <p:cNvSpPr/>
          <p:nvPr/>
        </p:nvSpPr>
        <p:spPr>
          <a:xfrm>
            <a:off x="1322037" y="2837856"/>
            <a:ext cx="1520725" cy="27137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121C360-FFC6-7C0D-B28C-46C7A02AC647}"/>
              </a:ext>
            </a:extLst>
          </p:cNvPr>
          <p:cNvSpPr/>
          <p:nvPr/>
        </p:nvSpPr>
        <p:spPr>
          <a:xfrm>
            <a:off x="1276317" y="5370447"/>
            <a:ext cx="1520725" cy="27137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3395FFC-8F6D-A68D-5C6E-786D59F7E410}"/>
              </a:ext>
            </a:extLst>
          </p:cNvPr>
          <p:cNvSpPr/>
          <p:nvPr/>
        </p:nvSpPr>
        <p:spPr>
          <a:xfrm>
            <a:off x="1242955" y="6610644"/>
            <a:ext cx="1520725" cy="27137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F2B2ABD-6EB1-0A79-DBD6-9B72CE03D582}"/>
              </a:ext>
            </a:extLst>
          </p:cNvPr>
          <p:cNvSpPr txBox="1"/>
          <p:nvPr/>
        </p:nvSpPr>
        <p:spPr>
          <a:xfrm>
            <a:off x="209904" y="166613"/>
            <a:ext cx="6434775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</a:t>
            </a:r>
            <a:r>
              <a:rPr lang="en-US" sz="1530" dirty="0">
                <a:latin typeface="Arial" panose="020B0604020202020204" pitchFamily="34" charset="0"/>
                <a:cs typeface="Arial" panose="020B0604020202020204" pitchFamily="34" charset="0"/>
              </a:rPr>
              <a:t>Full, uncropped western image for Figure 3n.</a:t>
            </a:r>
          </a:p>
        </p:txBody>
      </p:sp>
    </p:spTree>
    <p:extLst>
      <p:ext uri="{BB962C8B-B14F-4D97-AF65-F5344CB8AC3E}">
        <p14:creationId xmlns:p14="http://schemas.microsoft.com/office/powerpoint/2010/main" val="2019944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5</TotalTime>
  <Words>49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ton, Damien</dc:creator>
  <cp:lastModifiedBy>Lyssiotis, Costas</cp:lastModifiedBy>
  <cp:revision>27</cp:revision>
  <dcterms:created xsi:type="dcterms:W3CDTF">2022-08-08T03:19:06Z</dcterms:created>
  <dcterms:modified xsi:type="dcterms:W3CDTF">2023-03-31T02:45:51Z</dcterms:modified>
</cp:coreProperties>
</file>